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4"/>
  </p:sldMasterIdLst>
  <p:notesMasterIdLst>
    <p:notesMasterId r:id="rId6"/>
  </p:notesMasterIdLst>
  <p:sldIdLst>
    <p:sldId id="265" r:id="rId5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0A0A4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99CB21E-37A8-431F-8F5D-2C5257FD31CD}" v="1" dt="2023-03-03T21:25:01.33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63" autoAdjust="0"/>
    <p:restoredTop sz="96805" autoAdjust="0"/>
  </p:normalViewPr>
  <p:slideViewPr>
    <p:cSldViewPr snapToGrid="0">
      <p:cViewPr varScale="1">
        <p:scale>
          <a:sx n="93" d="100"/>
          <a:sy n="93" d="100"/>
        </p:scale>
        <p:origin x="198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0BAB28-32FD-40D5-8D1F-7254121A98D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EDF786-BF0A-4742-A046-75F592D5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4745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arenR"/>
            </a:pPr>
            <a:endParaRPr lang="en-US" altLang="zh-CN" sz="1200" b="0" i="0" u="none" strike="noStrike" kern="1200" baseline="0" dirty="0">
              <a:solidFill>
                <a:srgbClr val="000000"/>
              </a:solidFill>
              <a:latin typeface="Calibri" panose="020F0502020204030204" pitchFamily="34" charset="0"/>
              <a:ea typeface="SimSun" panose="02010600030101010101" pitchFamily="2" charset="-122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EDF786-BF0A-4742-A046-75F592D5157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8351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06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21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691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499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704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560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158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792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0698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622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759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FB428-A5BF-4724-B039-F34EC365BF82}" type="datetimeFigureOut">
              <a:rPr lang="en-US" smtClean="0"/>
              <a:t>8/2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43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394CB94-8CAA-CBBA-0656-14C2361795EB}"/>
              </a:ext>
            </a:extLst>
          </p:cNvPr>
          <p:cNvSpPr txBox="1"/>
          <p:nvPr/>
        </p:nvSpPr>
        <p:spPr>
          <a:xfrm>
            <a:off x="6861959" y="1500085"/>
            <a:ext cx="16979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Helvetica" pitchFamily="2" charset="0"/>
              </a:rPr>
              <a:t>Su</a:t>
            </a:r>
            <a:r>
              <a:rPr lang="en-US" sz="1200" dirty="0">
                <a:latin typeface="Helvetica" pitchFamily="2" charset="0"/>
              </a:rPr>
              <a:t> et al., Suppl. Fig. 6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FEDA7C4F-8BB7-9C01-58C1-EAE418BC7860}"/>
              </a:ext>
            </a:extLst>
          </p:cNvPr>
          <p:cNvGrpSpPr/>
          <p:nvPr/>
        </p:nvGrpSpPr>
        <p:grpSpPr>
          <a:xfrm>
            <a:off x="2701306" y="2303814"/>
            <a:ext cx="5874282" cy="1959430"/>
            <a:chOff x="2701306" y="2303814"/>
            <a:chExt cx="5874282" cy="1959430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AE058B5A-AD82-28A4-E68A-210E74C10A19}"/>
                </a:ext>
              </a:extLst>
            </p:cNvPr>
            <p:cNvGrpSpPr/>
            <p:nvPr/>
          </p:nvGrpSpPr>
          <p:grpSpPr>
            <a:xfrm>
              <a:off x="2701306" y="2602810"/>
              <a:ext cx="3016589" cy="1644646"/>
              <a:chOff x="4292600" y="2590935"/>
              <a:chExt cx="3016589" cy="1644646"/>
            </a:xfrm>
          </p:grpSpPr>
          <p:pic>
            <p:nvPicPr>
              <p:cNvPr id="137" name="Content Placeholder 5">
                <a:extLst>
                  <a:ext uri="{FF2B5EF4-FFF2-40B4-BE49-F238E27FC236}">
                    <a16:creationId xmlns:a16="http://schemas.microsoft.com/office/drawing/2014/main" id="{786D32CE-9603-4D16-8731-9A46979FA9E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  <a:lum bright="20000" contrast="40000"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17994" t="61204" r="76888" b="29637"/>
              <a:stretch/>
            </p:blipFill>
            <p:spPr>
              <a:xfrm rot="5400000">
                <a:off x="5529357" y="3327698"/>
                <a:ext cx="504942" cy="116848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8" name="Content Placeholder 5">
                <a:extLst>
                  <a:ext uri="{FF2B5EF4-FFF2-40B4-BE49-F238E27FC236}">
                    <a16:creationId xmlns:a16="http://schemas.microsoft.com/office/drawing/2014/main" id="{73955326-350B-413C-9CB4-50B08C1630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  <a:lum bright="20000" contrast="40000"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18116" t="73267" r="76766" b="17575"/>
              <a:stretch/>
            </p:blipFill>
            <p:spPr>
              <a:xfrm rot="5400000">
                <a:off x="5529360" y="2783752"/>
                <a:ext cx="504940" cy="116848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36BFA7AD-5B93-4CA8-8108-953EB2F72FA6}"/>
                  </a:ext>
                </a:extLst>
              </p:cNvPr>
              <p:cNvSpPr txBox="1"/>
              <p:nvPr/>
            </p:nvSpPr>
            <p:spPr>
              <a:xfrm rot="19279322">
                <a:off x="5215641" y="2691041"/>
                <a:ext cx="81785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>
                    <a:latin typeface="Helvetica" pitchFamily="2" charset="0"/>
                    <a:cs typeface="Hadassah Friedlaender" panose="020B0604020202020204" pitchFamily="18" charset="-79"/>
                  </a:rPr>
                  <a:t>PMIS-EV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2B5D3B58-64C6-4B88-AD86-402CF401B011}"/>
                  </a:ext>
                </a:extLst>
              </p:cNvPr>
              <p:cNvSpPr txBox="1"/>
              <p:nvPr/>
            </p:nvSpPr>
            <p:spPr>
              <a:xfrm rot="19279322">
                <a:off x="5559700" y="2595405"/>
                <a:ext cx="1124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>
                    <a:latin typeface="Helvetica" pitchFamily="2" charset="0"/>
                    <a:cs typeface="Hadassah Friedlaender" panose="020B0604020202020204" pitchFamily="18" charset="-79"/>
                  </a:rPr>
                  <a:t>PMIS-miR-23</a:t>
                </a: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2B88A6BD-C7DF-4DF4-B103-ED9FF3E3CF20}"/>
                  </a:ext>
                </a:extLst>
              </p:cNvPr>
              <p:cNvSpPr txBox="1"/>
              <p:nvPr/>
            </p:nvSpPr>
            <p:spPr>
              <a:xfrm rot="19279322">
                <a:off x="5935727" y="2590935"/>
                <a:ext cx="1124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>
                    <a:latin typeface="Helvetica" pitchFamily="2" charset="0"/>
                    <a:cs typeface="Hadassah Friedlaender" panose="020B0604020202020204" pitchFamily="18" charset="-79"/>
                  </a:rPr>
                  <a:t>PMIS-miR-24</a:t>
                </a:r>
              </a:p>
            </p:txBody>
          </p: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DC971E74-F2C3-4B7F-9CA4-18B4B1FFFD8A}"/>
                  </a:ext>
                </a:extLst>
              </p:cNvPr>
              <p:cNvSpPr txBox="1"/>
              <p:nvPr/>
            </p:nvSpPr>
            <p:spPr>
              <a:xfrm>
                <a:off x="6342258" y="3213867"/>
                <a:ext cx="9669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Helvetica" pitchFamily="2" charset="0"/>
                    <a:cs typeface="Hadassah Friedlaender" panose="020B0604020202020204" pitchFamily="18" charset="-79"/>
                  </a:rPr>
                  <a:t>H3K36me1</a:t>
                </a:r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B17D164A-62C8-43FD-BD38-118478C53EE5}"/>
                  </a:ext>
                </a:extLst>
              </p:cNvPr>
              <p:cNvSpPr txBox="1"/>
              <p:nvPr/>
            </p:nvSpPr>
            <p:spPr>
              <a:xfrm>
                <a:off x="6347109" y="3786797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Helvetica" pitchFamily="2" charset="0"/>
                    <a:cs typeface="Hadassah Friedlaender" panose="020B0604020202020204" pitchFamily="18" charset="-79"/>
                  </a:rPr>
                  <a:t>H3</a:t>
                </a:r>
              </a:p>
            </p:txBody>
          </p:sp>
          <p:cxnSp>
            <p:nvCxnSpPr>
              <p:cNvPr id="144" name="Straight Connector 143">
                <a:extLst>
                  <a:ext uri="{FF2B5EF4-FFF2-40B4-BE49-F238E27FC236}">
                    <a16:creationId xmlns:a16="http://schemas.microsoft.com/office/drawing/2014/main" id="{5E518C2B-CD8A-40E1-B82F-3A819C4AC89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69970" y="3547864"/>
                <a:ext cx="127616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0F01B2ED-B3CE-4865-8010-4DD784736EB4}"/>
                  </a:ext>
                </a:extLst>
              </p:cNvPr>
              <p:cNvSpPr txBox="1"/>
              <p:nvPr/>
            </p:nvSpPr>
            <p:spPr>
              <a:xfrm>
                <a:off x="4513143" y="2988567"/>
                <a:ext cx="62709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0kDa</a:t>
                </a:r>
              </a:p>
            </p:txBody>
          </p:sp>
          <p:cxnSp>
            <p:nvCxnSpPr>
              <p:cNvPr id="146" name="Straight Connector 145">
                <a:extLst>
                  <a:ext uri="{FF2B5EF4-FFF2-40B4-BE49-F238E27FC236}">
                    <a16:creationId xmlns:a16="http://schemas.microsoft.com/office/drawing/2014/main" id="{46558838-8DD6-46B9-BCB1-9AC7CD880B6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69970" y="3131366"/>
                <a:ext cx="127616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A3D90C75-F395-4114-9003-DCB1DFC62E49}"/>
                  </a:ext>
                </a:extLst>
              </p:cNvPr>
              <p:cNvSpPr txBox="1"/>
              <p:nvPr/>
            </p:nvSpPr>
            <p:spPr>
              <a:xfrm>
                <a:off x="4318000" y="3408260"/>
                <a:ext cx="826985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200" dirty="0">
                    <a:latin typeface="Helvetica" pitchFamily="2" charset="0"/>
                  </a:rPr>
                  <a:t>15kDa</a:t>
                </a:r>
              </a:p>
            </p:txBody>
          </p:sp>
          <p:grpSp>
            <p:nvGrpSpPr>
              <p:cNvPr id="148" name="Group 147">
                <a:extLst>
                  <a:ext uri="{FF2B5EF4-FFF2-40B4-BE49-F238E27FC236}">
                    <a16:creationId xmlns:a16="http://schemas.microsoft.com/office/drawing/2014/main" id="{607B8BFF-D556-4115-AE7C-801E1B03E349}"/>
                  </a:ext>
                </a:extLst>
              </p:cNvPr>
              <p:cNvGrpSpPr/>
              <p:nvPr/>
            </p:nvGrpSpPr>
            <p:grpSpPr>
              <a:xfrm>
                <a:off x="4292600" y="3576989"/>
                <a:ext cx="904986" cy="658592"/>
                <a:chOff x="1150742" y="4742919"/>
                <a:chExt cx="904986" cy="658592"/>
              </a:xfrm>
            </p:grpSpPr>
            <p:cxnSp>
              <p:nvCxnSpPr>
                <p:cNvPr id="149" name="Straight Connector 148">
                  <a:extLst>
                    <a:ext uri="{FF2B5EF4-FFF2-40B4-BE49-F238E27FC236}">
                      <a16:creationId xmlns:a16="http://schemas.microsoft.com/office/drawing/2014/main" id="{3CACCBD8-11D9-4E63-9110-098ED382E67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28112" y="5264116"/>
                  <a:ext cx="127616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50" name="TextBox 149">
                  <a:extLst>
                    <a:ext uri="{FF2B5EF4-FFF2-40B4-BE49-F238E27FC236}">
                      <a16:creationId xmlns:a16="http://schemas.microsoft.com/office/drawing/2014/main" id="{8038DC70-A7AE-4281-9FC5-54455299B9BB}"/>
                    </a:ext>
                  </a:extLst>
                </p:cNvPr>
                <p:cNvSpPr txBox="1"/>
                <p:nvPr/>
              </p:nvSpPr>
              <p:spPr>
                <a:xfrm>
                  <a:off x="1150742" y="4742919"/>
                  <a:ext cx="84763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0kDa</a:t>
                  </a:r>
                </a:p>
              </p:txBody>
            </p:sp>
            <p:cxnSp>
              <p:nvCxnSpPr>
                <p:cNvPr id="151" name="Straight Connector 150">
                  <a:extLst>
                    <a:ext uri="{FF2B5EF4-FFF2-40B4-BE49-F238E27FC236}">
                      <a16:creationId xmlns:a16="http://schemas.microsoft.com/office/drawing/2014/main" id="{40ADE394-A174-4005-91EA-491DB50A2F0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28112" y="4847618"/>
                  <a:ext cx="127616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52" name="TextBox 151">
                  <a:extLst>
                    <a:ext uri="{FF2B5EF4-FFF2-40B4-BE49-F238E27FC236}">
                      <a16:creationId xmlns:a16="http://schemas.microsoft.com/office/drawing/2014/main" id="{65DABC6B-FF19-4BF5-8055-742241590707}"/>
                    </a:ext>
                  </a:extLst>
                </p:cNvPr>
                <p:cNvSpPr txBox="1"/>
                <p:nvPr/>
              </p:nvSpPr>
              <p:spPr>
                <a:xfrm>
                  <a:off x="1252342" y="5124512"/>
                  <a:ext cx="75078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r"/>
                  <a:r>
                    <a:rPr lang="en-US" sz="1200" dirty="0">
                      <a:latin typeface="Helvetica" pitchFamily="2" charset="0"/>
                    </a:rPr>
                    <a:t>15kDa</a:t>
                  </a:r>
                </a:p>
              </p:txBody>
            </p:sp>
          </p:grp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F041A3BE-D705-D868-C21C-6C440392BF46}"/>
                </a:ext>
              </a:extLst>
            </p:cNvPr>
            <p:cNvGrpSpPr/>
            <p:nvPr/>
          </p:nvGrpSpPr>
          <p:grpSpPr>
            <a:xfrm>
              <a:off x="5629781" y="2656822"/>
              <a:ext cx="2945807" cy="1606422"/>
              <a:chOff x="6057293" y="2502443"/>
              <a:chExt cx="2945807" cy="1606422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EE8E33C6-158D-F091-CA59-1F5702E50F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0"/>
                        </a14:imgEffect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18041" t="57386"/>
              <a:stretch/>
            </p:blipFill>
            <p:spPr>
              <a:xfrm>
                <a:off x="7011697" y="3654249"/>
                <a:ext cx="1038236" cy="45461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4AF66C86-39DE-ADD2-BD17-664CD71290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36580" y="3684690"/>
                <a:ext cx="127616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B8A061C5-7DFD-7B11-698F-4EC531841832}"/>
                  </a:ext>
                </a:extLst>
              </p:cNvPr>
              <p:cNvSpPr txBox="1"/>
              <p:nvPr/>
            </p:nvSpPr>
            <p:spPr>
              <a:xfrm>
                <a:off x="6057293" y="3530801"/>
                <a:ext cx="8221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0kDa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BDCCBC9E-AB9E-A17C-61AE-51DDE7169EF8}"/>
                  </a:ext>
                </a:extLst>
              </p:cNvPr>
              <p:cNvSpPr txBox="1"/>
              <p:nvPr/>
            </p:nvSpPr>
            <p:spPr>
              <a:xfrm>
                <a:off x="8059920" y="3739829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H3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239BBBB3-8480-BFDF-0F52-98EA847545C8}"/>
                  </a:ext>
                </a:extLst>
              </p:cNvPr>
              <p:cNvSpPr txBox="1"/>
              <p:nvPr/>
            </p:nvSpPr>
            <p:spPr>
              <a:xfrm>
                <a:off x="8036169" y="3158881"/>
                <a:ext cx="9669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H3K36me2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3A7C8C7-7C2E-EF21-A4EC-AC6D5CF9416D}"/>
                  </a:ext>
                </a:extLst>
              </p:cNvPr>
              <p:cNvSpPr txBox="1"/>
              <p:nvPr/>
            </p:nvSpPr>
            <p:spPr>
              <a:xfrm rot="19190403">
                <a:off x="6992547" y="2615184"/>
                <a:ext cx="81785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>
                    <a:latin typeface="Helvetica" pitchFamily="2" charset="0"/>
                  </a:rPr>
                  <a:t>PMIS-EV</a:t>
                </a:r>
                <a:endParaRPr lang="en-US" sz="1200" b="1" dirty="0">
                  <a:latin typeface="Helvetica" pitchFamily="2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3A7698F-4021-051C-C2BF-E227235531C7}"/>
                  </a:ext>
                </a:extLst>
              </p:cNvPr>
              <p:cNvSpPr txBox="1"/>
              <p:nvPr/>
            </p:nvSpPr>
            <p:spPr>
              <a:xfrm rot="19220169">
                <a:off x="7341655" y="2502443"/>
                <a:ext cx="1167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>
                    <a:latin typeface="Helvetica" pitchFamily="2" charset="0"/>
                  </a:rPr>
                  <a:t>PMIS-miR-23 </a:t>
                </a:r>
                <a:endParaRPr lang="en-US" sz="1200" b="1" dirty="0">
                  <a:latin typeface="Helvetica" pitchFamily="2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41D9B51-93C9-51AD-F1AE-119089986AD1}"/>
                  </a:ext>
                </a:extLst>
              </p:cNvPr>
              <p:cNvSpPr txBox="1"/>
              <p:nvPr/>
            </p:nvSpPr>
            <p:spPr>
              <a:xfrm rot="19190320">
                <a:off x="7674562" y="2514322"/>
                <a:ext cx="1167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>
                    <a:latin typeface="Helvetica" pitchFamily="2" charset="0"/>
                  </a:rPr>
                  <a:t>PMIS-miR-24</a:t>
                </a:r>
                <a:endParaRPr lang="en-US" sz="1200" b="1" dirty="0">
                  <a:latin typeface="Helvetica" pitchFamily="2" charset="0"/>
                </a:endParaRPr>
              </a:p>
            </p:txBody>
          </p:sp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0241729F-9F82-DD88-96FD-24874220445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aturation sat="0"/>
                        </a14:imgEffect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40914" t="54994"/>
              <a:stretch/>
            </p:blipFill>
            <p:spPr>
              <a:xfrm>
                <a:off x="7011696" y="3017524"/>
                <a:ext cx="1038236" cy="59257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45A121A7-1B61-E17C-0628-59CFB70DD7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60330" y="3077744"/>
                <a:ext cx="127616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9A7A9F77-B422-99FB-64BB-FC279F78EE45}"/>
                  </a:ext>
                </a:extLst>
              </p:cNvPr>
              <p:cNvSpPr txBox="1"/>
              <p:nvPr/>
            </p:nvSpPr>
            <p:spPr>
              <a:xfrm>
                <a:off x="6081043" y="2923855"/>
                <a:ext cx="8221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0kDa</a:t>
                </a:r>
              </a:p>
            </p:txBody>
          </p: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6C3C74A-B8EB-BE10-79B0-72D7FBB6301D}"/>
                </a:ext>
              </a:extLst>
            </p:cNvPr>
            <p:cNvSpPr txBox="1"/>
            <p:nvPr/>
          </p:nvSpPr>
          <p:spPr>
            <a:xfrm>
              <a:off x="2956955" y="2303814"/>
              <a:ext cx="3329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</a:rPr>
                <a:t>A 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836F8DA-37BB-A1C1-DD48-1EB782048A3B}"/>
                </a:ext>
              </a:extLst>
            </p:cNvPr>
            <p:cNvSpPr txBox="1"/>
            <p:nvPr/>
          </p:nvSpPr>
          <p:spPr>
            <a:xfrm>
              <a:off x="5888181" y="2420588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</a:rPr>
                <a:t>B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63911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8B87BA2AB25E442BD3E26FFCCB4725E" ma:contentTypeVersion="14" ma:contentTypeDescription="Create a new document." ma:contentTypeScope="" ma:versionID="49af1c8a26ae5946cd5b396a27bb08e8">
  <xsd:schema xmlns:xsd="http://www.w3.org/2001/XMLSchema" xmlns:xs="http://www.w3.org/2001/XMLSchema" xmlns:p="http://schemas.microsoft.com/office/2006/metadata/properties" xmlns:ns3="1fe4a7e6-0781-4223-92a9-cff86e5a1a8b" xmlns:ns4="379de845-6c3c-40ac-b46f-2ff42365e8a1" targetNamespace="http://schemas.microsoft.com/office/2006/metadata/properties" ma:root="true" ma:fieldsID="e94493a0dda3e71182790e9de226d6ff" ns3:_="" ns4:_="">
    <xsd:import namespace="1fe4a7e6-0781-4223-92a9-cff86e5a1a8b"/>
    <xsd:import namespace="379de845-6c3c-40ac-b46f-2ff42365e8a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e4a7e6-0781-4223-92a9-cff86e5a1a8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79de845-6c3c-40ac-b46f-2ff42365e8a1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C9FE77A-C817-4A7E-BC3E-F7DADD89B1D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E242034-1141-4B10-9E97-BBA0B09643D9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379de845-6c3c-40ac-b46f-2ff42365e8a1"/>
    <ds:schemaRef ds:uri="http://purl.org/dc/elements/1.1/"/>
    <ds:schemaRef ds:uri="http://schemas.microsoft.com/office/2006/metadata/properties"/>
    <ds:schemaRef ds:uri="1fe4a7e6-0781-4223-92a9-cff86e5a1a8b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FB082C0F-5B64-4AF4-80A5-545CDB20AC9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e4a7e6-0781-4223-92a9-cff86e5a1a8b"/>
    <ds:schemaRef ds:uri="379de845-6c3c-40ac-b46f-2ff42365e8a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3</TotalTime>
  <Words>28</Words>
  <Application>Microsoft Macintosh PowerPoint</Application>
  <PresentationFormat>Custom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, Dan</dc:creator>
  <cp:lastModifiedBy>Microsoft Office User</cp:lastModifiedBy>
  <cp:revision>12</cp:revision>
  <dcterms:created xsi:type="dcterms:W3CDTF">2022-10-11T15:48:40Z</dcterms:created>
  <dcterms:modified xsi:type="dcterms:W3CDTF">2023-08-23T22:02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8B87BA2AB25E442BD3E26FFCCB4725E</vt:lpwstr>
  </property>
</Properties>
</file>